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438" r:id="rId2"/>
    <p:sldId id="443" r:id="rId3"/>
    <p:sldId id="444" r:id="rId4"/>
    <p:sldId id="445" r:id="rId5"/>
    <p:sldId id="446" r:id="rId6"/>
    <p:sldId id="447" r:id="rId7"/>
    <p:sldId id="448" r:id="rId8"/>
  </p:sldIdLst>
  <p:sldSz cx="6264275" cy="8421688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7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turi Dasgupta" initials="KD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66"/>
    <a:srgbClr val="D0EBB3"/>
    <a:srgbClr val="FF99FF"/>
    <a:srgbClr val="FF6600"/>
    <a:srgbClr val="FF66CC"/>
    <a:srgbClr val="7C0E11"/>
    <a:srgbClr val="CC00CC"/>
    <a:srgbClr val="FF3399"/>
    <a:srgbClr val="FF5050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166" autoAdjust="0"/>
    <p:restoredTop sz="96405" autoAdjust="0"/>
  </p:normalViewPr>
  <p:slideViewPr>
    <p:cSldViewPr>
      <p:cViewPr varScale="1">
        <p:scale>
          <a:sx n="104" d="100"/>
          <a:sy n="104" d="100"/>
        </p:scale>
        <p:origin x="3512" y="208"/>
      </p:cViewPr>
      <p:guideLst>
        <p:guide orient="horz" pos="2653"/>
        <p:guide pos="197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843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54238" y="685800"/>
            <a:ext cx="2549525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36CED8E8-F137-4E73-9AD7-23FE4FCFC60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9925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3"/>
            <a:ext cx="5324634" cy="18052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/>
            </a:lvl1pPr>
            <a:lvl2pPr marL="313228" indent="0" algn="ctr">
              <a:buNone/>
              <a:defRPr/>
            </a:lvl2pPr>
            <a:lvl3pPr marL="626455" indent="0" algn="ctr">
              <a:buNone/>
              <a:defRPr/>
            </a:lvl3pPr>
            <a:lvl4pPr marL="939683" indent="0" algn="ctr">
              <a:buNone/>
              <a:defRPr/>
            </a:lvl4pPr>
            <a:lvl5pPr marL="1252911" indent="0" algn="ctr">
              <a:buNone/>
              <a:defRPr/>
            </a:lvl5pPr>
            <a:lvl6pPr marL="1566139" indent="0" algn="ctr">
              <a:buNone/>
              <a:defRPr/>
            </a:lvl6pPr>
            <a:lvl7pPr marL="1879366" indent="0" algn="ctr">
              <a:buNone/>
              <a:defRPr/>
            </a:lvl7pPr>
            <a:lvl8pPr marL="2192594" indent="0" algn="ctr">
              <a:buNone/>
              <a:defRPr/>
            </a:lvl8pPr>
            <a:lvl9pPr marL="2505822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A1C836-FEAA-4328-83B6-58AEE6B47C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ED3321-3BED-42F2-BC36-F92A276C45B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41599" y="337259"/>
            <a:ext cx="1409462" cy="71857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3214" y="337259"/>
            <a:ext cx="4123981" cy="718572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2F6389-D760-4E5D-BC4A-455534D19AD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264A87-A24C-4273-8D2A-B7B27C6FF2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4" y="5411715"/>
            <a:ext cx="5324634" cy="1672641"/>
          </a:xfrm>
        </p:spPr>
        <p:txBody>
          <a:bodyPr anchor="t"/>
          <a:lstStyle>
            <a:lvl1pPr algn="l">
              <a:defRPr sz="274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4" y="3569471"/>
            <a:ext cx="5324634" cy="1842244"/>
          </a:xfrm>
        </p:spPr>
        <p:txBody>
          <a:bodyPr anchor="b"/>
          <a:lstStyle>
            <a:lvl1pPr marL="0" indent="0">
              <a:buNone/>
              <a:defRPr sz="1370"/>
            </a:lvl1pPr>
            <a:lvl2pPr marL="313228" indent="0">
              <a:buNone/>
              <a:defRPr sz="1233"/>
            </a:lvl2pPr>
            <a:lvl3pPr marL="626455" indent="0">
              <a:buNone/>
              <a:defRPr sz="1096"/>
            </a:lvl3pPr>
            <a:lvl4pPr marL="939683" indent="0">
              <a:buNone/>
              <a:defRPr sz="959"/>
            </a:lvl4pPr>
            <a:lvl5pPr marL="1252911" indent="0">
              <a:buNone/>
              <a:defRPr sz="959"/>
            </a:lvl5pPr>
            <a:lvl6pPr marL="1566139" indent="0">
              <a:buNone/>
              <a:defRPr sz="959"/>
            </a:lvl6pPr>
            <a:lvl7pPr marL="1879366" indent="0">
              <a:buNone/>
              <a:defRPr sz="959"/>
            </a:lvl7pPr>
            <a:lvl8pPr marL="2192594" indent="0">
              <a:buNone/>
              <a:defRPr sz="959"/>
            </a:lvl8pPr>
            <a:lvl9pPr marL="2505822" indent="0">
              <a:buNone/>
              <a:defRPr sz="95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4B0689-EDCB-414C-B7F2-D76726E130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3214" y="1965061"/>
            <a:ext cx="2766721" cy="5557925"/>
          </a:xfrm>
        </p:spPr>
        <p:txBody>
          <a:bodyPr/>
          <a:lstStyle>
            <a:lvl1pPr>
              <a:defRPr sz="1918"/>
            </a:lvl1pPr>
            <a:lvl2pPr>
              <a:defRPr sz="1644"/>
            </a:lvl2pPr>
            <a:lvl3pPr>
              <a:defRPr sz="1370"/>
            </a:lvl3pPr>
            <a:lvl4pPr>
              <a:defRPr sz="1233"/>
            </a:lvl4pPr>
            <a:lvl5pPr>
              <a:defRPr sz="1233"/>
            </a:lvl5pPr>
            <a:lvl6pPr>
              <a:defRPr sz="1233"/>
            </a:lvl6pPr>
            <a:lvl7pPr>
              <a:defRPr sz="1233"/>
            </a:lvl7pPr>
            <a:lvl8pPr>
              <a:defRPr sz="1233"/>
            </a:lvl8pPr>
            <a:lvl9pPr>
              <a:defRPr sz="12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4340" y="1965061"/>
            <a:ext cx="2766721" cy="5557925"/>
          </a:xfrm>
        </p:spPr>
        <p:txBody>
          <a:bodyPr/>
          <a:lstStyle>
            <a:lvl1pPr>
              <a:defRPr sz="1918"/>
            </a:lvl1pPr>
            <a:lvl2pPr>
              <a:defRPr sz="1644"/>
            </a:lvl2pPr>
            <a:lvl3pPr>
              <a:defRPr sz="1370"/>
            </a:lvl3pPr>
            <a:lvl4pPr>
              <a:defRPr sz="1233"/>
            </a:lvl4pPr>
            <a:lvl5pPr>
              <a:defRPr sz="1233"/>
            </a:lvl5pPr>
            <a:lvl6pPr>
              <a:defRPr sz="1233"/>
            </a:lvl6pPr>
            <a:lvl7pPr>
              <a:defRPr sz="1233"/>
            </a:lvl7pPr>
            <a:lvl8pPr>
              <a:defRPr sz="1233"/>
            </a:lvl8pPr>
            <a:lvl9pPr>
              <a:defRPr sz="12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F2646C-AE7C-4505-A392-F6DFDD4DC10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7"/>
            <a:ext cx="2767809" cy="4852219"/>
          </a:xfrm>
        </p:spPr>
        <p:txBody>
          <a:bodyPr/>
          <a:lstStyle>
            <a:lvl1pPr>
              <a:defRPr sz="1644"/>
            </a:lvl1pPr>
            <a:lvl2pPr>
              <a:defRPr sz="1370"/>
            </a:lvl2pPr>
            <a:lvl3pPr>
              <a:defRPr sz="1233"/>
            </a:lvl3pPr>
            <a:lvl4pPr>
              <a:defRPr sz="1096"/>
            </a:lvl4pPr>
            <a:lvl5pPr>
              <a:defRPr sz="1096"/>
            </a:lvl5pPr>
            <a:lvl6pPr>
              <a:defRPr sz="1096"/>
            </a:lvl6pPr>
            <a:lvl7pPr>
              <a:defRPr sz="1096"/>
            </a:lvl7pPr>
            <a:lvl8pPr>
              <a:defRPr sz="1096"/>
            </a:lvl8pPr>
            <a:lvl9pPr>
              <a:defRPr sz="10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5" y="1885133"/>
            <a:ext cx="2768897" cy="785634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5" y="2670767"/>
            <a:ext cx="2768897" cy="4852219"/>
          </a:xfrm>
        </p:spPr>
        <p:txBody>
          <a:bodyPr/>
          <a:lstStyle>
            <a:lvl1pPr>
              <a:defRPr sz="1644"/>
            </a:lvl1pPr>
            <a:lvl2pPr>
              <a:defRPr sz="1370"/>
            </a:lvl2pPr>
            <a:lvl3pPr>
              <a:defRPr sz="1233"/>
            </a:lvl3pPr>
            <a:lvl4pPr>
              <a:defRPr sz="1096"/>
            </a:lvl4pPr>
            <a:lvl5pPr>
              <a:defRPr sz="1096"/>
            </a:lvl5pPr>
            <a:lvl6pPr>
              <a:defRPr sz="1096"/>
            </a:lvl6pPr>
            <a:lvl7pPr>
              <a:defRPr sz="1096"/>
            </a:lvl7pPr>
            <a:lvl8pPr>
              <a:defRPr sz="1096"/>
            </a:lvl8pPr>
            <a:lvl9pPr>
              <a:defRPr sz="10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4590FB-787C-404F-9469-38E36DBB24D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B45914-49D0-4830-B7E7-2C18F677A5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5180D1-F494-4DC6-9C59-4BB7353FEC7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3" cy="1427008"/>
          </a:xfrm>
        </p:spPr>
        <p:txBody>
          <a:bodyPr anchor="b"/>
          <a:lstStyle>
            <a:lvl1pPr algn="l">
              <a:defRPr sz="137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7" y="335309"/>
            <a:ext cx="3501904" cy="7187677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3" cy="5760669"/>
          </a:xfrm>
        </p:spPr>
        <p:txBody>
          <a:bodyPr/>
          <a:lstStyle>
            <a:lvl1pPr marL="0" indent="0">
              <a:buNone/>
              <a:defRPr sz="959"/>
            </a:lvl1pPr>
            <a:lvl2pPr marL="313228" indent="0">
              <a:buNone/>
              <a:defRPr sz="822"/>
            </a:lvl2pPr>
            <a:lvl3pPr marL="626455" indent="0">
              <a:buNone/>
              <a:defRPr sz="685"/>
            </a:lvl3pPr>
            <a:lvl4pPr marL="939683" indent="0">
              <a:buNone/>
              <a:defRPr sz="617"/>
            </a:lvl4pPr>
            <a:lvl5pPr marL="1252911" indent="0">
              <a:buNone/>
              <a:defRPr sz="617"/>
            </a:lvl5pPr>
            <a:lvl6pPr marL="1566139" indent="0">
              <a:buNone/>
              <a:defRPr sz="617"/>
            </a:lvl6pPr>
            <a:lvl7pPr marL="1879366" indent="0">
              <a:buNone/>
              <a:defRPr sz="617"/>
            </a:lvl7pPr>
            <a:lvl8pPr marL="2192594" indent="0">
              <a:buNone/>
              <a:defRPr sz="617"/>
            </a:lvl8pPr>
            <a:lvl9pPr marL="2505822" indent="0">
              <a:buNone/>
              <a:defRPr sz="61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3E7E74-5BED-46F2-9755-BC9DEA24859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1"/>
            <a:ext cx="3758565" cy="695960"/>
          </a:xfrm>
        </p:spPr>
        <p:txBody>
          <a:bodyPr anchor="b"/>
          <a:lstStyle>
            <a:lvl1pPr algn="l">
              <a:defRPr sz="137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1"/>
            <a:ext cx="3758565" cy="988378"/>
          </a:xfrm>
        </p:spPr>
        <p:txBody>
          <a:bodyPr/>
          <a:lstStyle>
            <a:lvl1pPr marL="0" indent="0">
              <a:buNone/>
              <a:defRPr sz="959"/>
            </a:lvl1pPr>
            <a:lvl2pPr marL="313228" indent="0">
              <a:buNone/>
              <a:defRPr sz="822"/>
            </a:lvl2pPr>
            <a:lvl3pPr marL="626455" indent="0">
              <a:buNone/>
              <a:defRPr sz="685"/>
            </a:lvl3pPr>
            <a:lvl4pPr marL="939683" indent="0">
              <a:buNone/>
              <a:defRPr sz="617"/>
            </a:lvl4pPr>
            <a:lvl5pPr marL="1252911" indent="0">
              <a:buNone/>
              <a:defRPr sz="617"/>
            </a:lvl5pPr>
            <a:lvl6pPr marL="1566139" indent="0">
              <a:buNone/>
              <a:defRPr sz="617"/>
            </a:lvl6pPr>
            <a:lvl7pPr marL="1879366" indent="0">
              <a:buNone/>
              <a:defRPr sz="617"/>
            </a:lvl7pPr>
            <a:lvl8pPr marL="2192594" indent="0">
              <a:buNone/>
              <a:defRPr sz="617"/>
            </a:lvl8pPr>
            <a:lvl9pPr marL="2505822" indent="0">
              <a:buNone/>
              <a:defRPr sz="61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754592-2CBE-4E2A-93C3-165D7F72F8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13214" y="337258"/>
            <a:ext cx="5637848" cy="14036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13214" y="1965061"/>
            <a:ext cx="5637848" cy="5557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13214" y="7669195"/>
            <a:ext cx="1461664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959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140294" y="7669195"/>
            <a:ext cx="1983687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959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489397" y="7669195"/>
            <a:ext cx="1461664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59"/>
            </a:lvl1pPr>
          </a:lstStyle>
          <a:p>
            <a:pPr>
              <a:defRPr/>
            </a:pPr>
            <a:fld id="{F6F8016A-C16B-4FB4-8698-94ADC36A62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5pPr>
      <a:lvl6pPr marL="313228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6pPr>
      <a:lvl7pPr marL="626455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7pPr>
      <a:lvl8pPr marL="939683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8pPr>
      <a:lvl9pPr marL="1252911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234921" indent="-234921" algn="l" rtl="0" eaLnBrk="0" fontAlgn="base" hangingPunct="0">
        <a:spcBef>
          <a:spcPct val="20000"/>
        </a:spcBef>
        <a:spcAft>
          <a:spcPct val="0"/>
        </a:spcAft>
        <a:buChar char="•"/>
        <a:defRPr sz="2192">
          <a:solidFill>
            <a:schemeClr val="tx1"/>
          </a:solidFill>
          <a:latin typeface="+mn-lt"/>
          <a:ea typeface="+mn-ea"/>
          <a:cs typeface="+mn-cs"/>
        </a:defRPr>
      </a:lvl1pPr>
      <a:lvl2pPr marL="508995" indent="-195767" algn="l" rtl="0" eaLnBrk="0" fontAlgn="base" hangingPunct="0">
        <a:spcBef>
          <a:spcPct val="20000"/>
        </a:spcBef>
        <a:spcAft>
          <a:spcPct val="0"/>
        </a:spcAft>
        <a:buChar char="–"/>
        <a:defRPr sz="1918">
          <a:solidFill>
            <a:schemeClr val="tx1"/>
          </a:solidFill>
          <a:latin typeface="+mn-lt"/>
          <a:cs typeface="+mn-cs"/>
        </a:defRPr>
      </a:lvl2pPr>
      <a:lvl3pPr marL="783069" indent="-156614" algn="l" rtl="0" eaLnBrk="0" fontAlgn="base" hangingPunct="0">
        <a:spcBef>
          <a:spcPct val="20000"/>
        </a:spcBef>
        <a:spcAft>
          <a:spcPct val="0"/>
        </a:spcAft>
        <a:buChar char="•"/>
        <a:defRPr sz="1644">
          <a:solidFill>
            <a:schemeClr val="tx1"/>
          </a:solidFill>
          <a:latin typeface="+mn-lt"/>
          <a:cs typeface="+mn-cs"/>
        </a:defRPr>
      </a:lvl3pPr>
      <a:lvl4pPr marL="1096297" indent="-156614" algn="l" rtl="0" eaLnBrk="0" fontAlgn="base" hangingPunct="0">
        <a:spcBef>
          <a:spcPct val="20000"/>
        </a:spcBef>
        <a:spcAft>
          <a:spcPct val="0"/>
        </a:spcAft>
        <a:buChar char="–"/>
        <a:defRPr sz="1370">
          <a:solidFill>
            <a:schemeClr val="tx1"/>
          </a:solidFill>
          <a:latin typeface="+mn-lt"/>
          <a:cs typeface="+mn-cs"/>
        </a:defRPr>
      </a:lvl4pPr>
      <a:lvl5pPr marL="1409525" indent="-156614" algn="l" rtl="0" eaLnBrk="0" fontAlgn="base" hangingPunct="0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5pPr>
      <a:lvl6pPr marL="1722752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6pPr>
      <a:lvl7pPr marL="2035980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7pPr>
      <a:lvl8pPr marL="2349208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8pPr>
      <a:lvl9pPr marL="2662436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/>
          <p:cNvGrpSpPr>
            <a:grpSpLocks noChangeAspect="1"/>
          </p:cNvGrpSpPr>
          <p:nvPr/>
        </p:nvGrpSpPr>
        <p:grpSpPr>
          <a:xfrm>
            <a:off x="179862" y="173268"/>
            <a:ext cx="5904551" cy="6426344"/>
            <a:chOff x="1909526" y="-171309"/>
            <a:chExt cx="6821429" cy="7040464"/>
          </a:xfrm>
        </p:grpSpPr>
        <p:grpSp>
          <p:nvGrpSpPr>
            <p:cNvPr id="29" name="Group 28"/>
            <p:cNvGrpSpPr/>
            <p:nvPr/>
          </p:nvGrpSpPr>
          <p:grpSpPr>
            <a:xfrm>
              <a:off x="1909526" y="-171309"/>
              <a:ext cx="6821429" cy="7040464"/>
              <a:chOff x="1909526" y="-171309"/>
              <a:chExt cx="6821429" cy="7040464"/>
            </a:xfrm>
          </p:grpSpPr>
          <p:grpSp>
            <p:nvGrpSpPr>
              <p:cNvPr id="4" name="Group 3"/>
              <p:cNvGrpSpPr>
                <a:grpSpLocks noChangeAspect="1"/>
              </p:cNvGrpSpPr>
              <p:nvPr/>
            </p:nvGrpSpPr>
            <p:grpSpPr>
              <a:xfrm>
                <a:off x="2181581" y="-171309"/>
                <a:ext cx="6406961" cy="1645920"/>
                <a:chOff x="881165" y="774662"/>
                <a:chExt cx="9148948" cy="2350325"/>
              </a:xfrm>
            </p:grpSpPr>
            <p:pic>
              <p:nvPicPr>
                <p:cNvPr id="5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81165" y="774662"/>
                  <a:ext cx="8060260" cy="23503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6" name="TextBox 5"/>
                <p:cNvSpPr txBox="1"/>
                <p:nvPr/>
              </p:nvSpPr>
              <p:spPr>
                <a:xfrm>
                  <a:off x="8698234" y="1981927"/>
                  <a:ext cx="1331879" cy="4519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4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itSEPp</a:t>
                  </a:r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1909526" y="674132"/>
                <a:ext cx="6821429" cy="6195023"/>
                <a:chOff x="1909526" y="674132"/>
                <a:chExt cx="6821429" cy="6195023"/>
              </a:xfrm>
            </p:grpSpPr>
            <p:grpSp>
              <p:nvGrpSpPr>
                <p:cNvPr id="8" name="Group 7"/>
                <p:cNvGrpSpPr>
                  <a:grpSpLocks noChangeAspect="1"/>
                </p:cNvGrpSpPr>
                <p:nvPr/>
              </p:nvGrpSpPr>
              <p:grpSpPr>
                <a:xfrm>
                  <a:off x="2057400" y="1391415"/>
                  <a:ext cx="6503775" cy="1402517"/>
                  <a:chOff x="579938" y="1596720"/>
                  <a:chExt cx="9491171" cy="2046739"/>
                </a:xfrm>
              </p:grpSpPr>
              <p:pic>
                <p:nvPicPr>
                  <p:cNvPr id="9" name="Picture 191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79938" y="1596720"/>
                    <a:ext cx="8006480" cy="204673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8846973" y="2636143"/>
                    <a:ext cx="1224136" cy="46188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4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itWAXp</a:t>
                    </a:r>
                  </a:p>
                </p:txBody>
              </p:sp>
            </p:grpSp>
            <p:grpSp>
              <p:nvGrpSpPr>
                <p:cNvPr id="11" name="Group 10"/>
                <p:cNvGrpSpPr>
                  <a:grpSpLocks noChangeAspect="1"/>
                </p:cNvGrpSpPr>
                <p:nvPr/>
              </p:nvGrpSpPr>
              <p:grpSpPr>
                <a:xfrm>
                  <a:off x="2226357" y="2529086"/>
                  <a:ext cx="6288542" cy="1463040"/>
                  <a:chOff x="897578" y="1371600"/>
                  <a:chExt cx="8989375" cy="2091394"/>
                </a:xfrm>
              </p:grpSpPr>
              <p:pic>
                <p:nvPicPr>
                  <p:cNvPr id="12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97578" y="1371600"/>
                    <a:ext cx="8044617" cy="209139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8820152" y="2366551"/>
                    <a:ext cx="1066801" cy="70440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4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itUNKp</a:t>
                    </a:r>
                  </a:p>
                </p:txBody>
              </p:sp>
            </p:grpSp>
            <p:sp>
              <p:nvSpPr>
                <p:cNvPr id="2" name="TextBox 1"/>
                <p:cNvSpPr txBox="1"/>
                <p:nvPr/>
              </p:nvSpPr>
              <p:spPr>
                <a:xfrm>
                  <a:off x="1909528" y="674132"/>
                  <a:ext cx="210379" cy="3165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4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909528" y="1976550"/>
                  <a:ext cx="210379" cy="3165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4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918160" y="3148164"/>
                  <a:ext cx="210379" cy="3165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4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grpSp>
              <p:nvGrpSpPr>
                <p:cNvPr id="17" name="Group 16"/>
                <p:cNvGrpSpPr>
                  <a:grpSpLocks noChangeAspect="1"/>
                </p:cNvGrpSpPr>
                <p:nvPr/>
              </p:nvGrpSpPr>
              <p:grpSpPr>
                <a:xfrm>
                  <a:off x="2232528" y="3662748"/>
                  <a:ext cx="6315487" cy="1280160"/>
                  <a:chOff x="914401" y="1508093"/>
                  <a:chExt cx="9476524" cy="1920907"/>
                </a:xfrm>
              </p:grpSpPr>
              <p:pic>
                <p:nvPicPr>
                  <p:cNvPr id="19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14401" y="1508093"/>
                    <a:ext cx="7945403" cy="192090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9171724" y="2330962"/>
                    <a:ext cx="1219201" cy="7394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4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itJuSacp</a:t>
                    </a:r>
                  </a:p>
                </p:txBody>
              </p:sp>
            </p:grpSp>
            <p:sp>
              <p:nvSpPr>
                <p:cNvPr id="18" name="TextBox 17"/>
                <p:cNvSpPr txBox="1"/>
                <p:nvPr/>
              </p:nvSpPr>
              <p:spPr>
                <a:xfrm>
                  <a:off x="1909528" y="4204554"/>
                  <a:ext cx="210379" cy="3165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4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grpSp>
              <p:nvGrpSpPr>
                <p:cNvPr id="21" name="Group 20"/>
                <p:cNvGrpSpPr>
                  <a:grpSpLocks noChangeAspect="1"/>
                </p:cNvGrpSpPr>
                <p:nvPr/>
              </p:nvGrpSpPr>
              <p:grpSpPr>
                <a:xfrm>
                  <a:off x="2273320" y="4520622"/>
                  <a:ext cx="6382362" cy="1371600"/>
                  <a:chOff x="1066800" y="2418263"/>
                  <a:chExt cx="8797912" cy="1890713"/>
                </a:xfrm>
              </p:grpSpPr>
              <p:pic>
                <p:nvPicPr>
                  <p:cNvPr id="22" name="Picture 85"/>
                  <p:cNvPicPr>
                    <a:picLocks noChangeAspect="1" noChangeArrowheads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t="22742"/>
                  <a:stretch>
                    <a:fillRect/>
                  </a:stretch>
                </p:blipFill>
                <p:spPr bwMode="auto">
                  <a:xfrm>
                    <a:off x="1066800" y="2418263"/>
                    <a:ext cx="7273925" cy="1890713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8645512" y="3266226"/>
                    <a:ext cx="1219200" cy="39495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4" i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itVO1/2p</a:t>
                    </a:r>
                    <a:endParaRPr lang="en-US" sz="754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4" name="TextBox 23"/>
                <p:cNvSpPr txBox="1"/>
                <p:nvPr/>
              </p:nvSpPr>
              <p:spPr>
                <a:xfrm>
                  <a:off x="1918160" y="5162034"/>
                  <a:ext cx="210379" cy="3165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4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</a:t>
                  </a:r>
                </a:p>
              </p:txBody>
            </p:sp>
            <p:grpSp>
              <p:nvGrpSpPr>
                <p:cNvPr id="25" name="Group 24"/>
                <p:cNvGrpSpPr>
                  <a:grpSpLocks noChangeAspect="1"/>
                </p:cNvGrpSpPr>
                <p:nvPr/>
              </p:nvGrpSpPr>
              <p:grpSpPr>
                <a:xfrm>
                  <a:off x="2261768" y="5771875"/>
                  <a:ext cx="6469187" cy="1097280"/>
                  <a:chOff x="944221" y="1999466"/>
                  <a:chExt cx="9383178" cy="1694659"/>
                </a:xfrm>
              </p:grpSpPr>
              <p:pic>
                <p:nvPicPr>
                  <p:cNvPr id="26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44221" y="1999466"/>
                    <a:ext cx="7729613" cy="169465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8879598" y="2644438"/>
                    <a:ext cx="1447801" cy="442506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4" i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amMybAp</a:t>
                    </a:r>
                    <a:endParaRPr lang="en-US" sz="754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8" name="TextBox 27"/>
                <p:cNvSpPr txBox="1"/>
                <p:nvPr/>
              </p:nvSpPr>
              <p:spPr>
                <a:xfrm>
                  <a:off x="1909526" y="6134759"/>
                  <a:ext cx="210379" cy="3165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4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</a:t>
                  </a:r>
                </a:p>
              </p:txBody>
            </p:sp>
          </p:grpSp>
        </p:grpSp>
        <p:sp>
          <p:nvSpPr>
            <p:cNvPr id="16" name="Bent Arrow 15"/>
            <p:cNvSpPr/>
            <p:nvPr/>
          </p:nvSpPr>
          <p:spPr>
            <a:xfrm>
              <a:off x="7414984" y="471008"/>
              <a:ext cx="91440" cy="182880"/>
            </a:xfrm>
            <a:prstGeom prst="bentArrow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368940" y="716040"/>
              <a:ext cx="457199" cy="396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4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7448510" y="3106621"/>
              <a:ext cx="149030" cy="25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404811" y="2158512"/>
              <a:ext cx="457199" cy="396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4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432956" y="3259733"/>
              <a:ext cx="457199" cy="396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4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450449" y="4250719"/>
              <a:ext cx="457199" cy="396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4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466300" y="5202121"/>
              <a:ext cx="457199" cy="396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4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7468929" y="6229482"/>
              <a:ext cx="457199" cy="396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4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432956" y="1980873"/>
              <a:ext cx="157956" cy="25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404811" y="593157"/>
              <a:ext cx="149030" cy="25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9" name="Bent Arrow 38"/>
            <p:cNvSpPr/>
            <p:nvPr/>
          </p:nvSpPr>
          <p:spPr>
            <a:xfrm>
              <a:off x="7478351" y="1899056"/>
              <a:ext cx="91440" cy="182880"/>
            </a:xfrm>
            <a:prstGeom prst="bentArrow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Bent Arrow 39"/>
            <p:cNvSpPr/>
            <p:nvPr/>
          </p:nvSpPr>
          <p:spPr>
            <a:xfrm>
              <a:off x="7477305" y="3030774"/>
              <a:ext cx="91440" cy="182880"/>
            </a:xfrm>
            <a:prstGeom prst="bentArrow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Bent Arrow 40"/>
            <p:cNvSpPr/>
            <p:nvPr/>
          </p:nvSpPr>
          <p:spPr>
            <a:xfrm>
              <a:off x="7507471" y="4065237"/>
              <a:ext cx="91440" cy="182880"/>
            </a:xfrm>
            <a:prstGeom prst="bentArrow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Bent Arrow 41"/>
            <p:cNvSpPr/>
            <p:nvPr/>
          </p:nvSpPr>
          <p:spPr>
            <a:xfrm>
              <a:off x="7515952" y="4968594"/>
              <a:ext cx="91440" cy="182880"/>
            </a:xfrm>
            <a:prstGeom prst="bentArrow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Bent Arrow 42"/>
            <p:cNvSpPr/>
            <p:nvPr/>
          </p:nvSpPr>
          <p:spPr>
            <a:xfrm>
              <a:off x="7506425" y="6006610"/>
              <a:ext cx="91440" cy="182880"/>
            </a:xfrm>
            <a:prstGeom prst="bentArrow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477583" y="4135789"/>
              <a:ext cx="149030" cy="25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7487157" y="5057793"/>
              <a:ext cx="149030" cy="25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7477583" y="6096372"/>
              <a:ext cx="149030" cy="25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8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sp>
        <p:nvSpPr>
          <p:cNvPr id="49" name="Rectangle 48">
            <a:extLst>
              <a:ext uri="{FF2B5EF4-FFF2-40B4-BE49-F238E27FC236}">
                <a16:creationId xmlns:a16="http://schemas.microsoft.com/office/drawing/2014/main" id="{1CA9E7AC-EBAC-8B43-87DA-A516A7BDABF5}"/>
              </a:ext>
            </a:extLst>
          </p:cNvPr>
          <p:cNvSpPr/>
          <p:nvPr/>
        </p:nvSpPr>
        <p:spPr>
          <a:xfrm>
            <a:off x="179862" y="232761"/>
            <a:ext cx="219027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. S1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252F5E5-23AA-2347-B1D5-3951ADAC2FF2}"/>
              </a:ext>
            </a:extLst>
          </p:cNvPr>
          <p:cNvSpPr/>
          <p:nvPr/>
        </p:nvSpPr>
        <p:spPr>
          <a:xfrm>
            <a:off x="449437" y="6852147"/>
            <a:ext cx="536539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; Fig S1.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chematic representation of the promoter region.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 various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is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elements identified in the candidate promoters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SEP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WAX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UNK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JuSac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itVO1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Plum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amMybAp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re shown as colored bars, respectively. The entire nucleotide sequences are available from the GenBank under the accession numbers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SEP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MK012379)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WAX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MK012380)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UNK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MK012381)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JuSac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MK012382),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itVO1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MK012383),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itVO2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MK012384)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amMybA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MK012380)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68910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0D4D1B9A-9258-6D4A-A193-CA348C230F3C}"/>
              </a:ext>
            </a:extLst>
          </p:cNvPr>
          <p:cNvGraphicFramePr>
            <a:graphicFrameLocks noGrp="1"/>
          </p:cNvGraphicFramePr>
          <p:nvPr/>
        </p:nvGraphicFramePr>
        <p:xfrm>
          <a:off x="291771" y="705644"/>
          <a:ext cx="5638800" cy="61722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2529">
                  <a:extLst>
                    <a:ext uri="{9D8B030D-6E8A-4147-A177-3AD203B41FA5}">
                      <a16:colId xmlns:a16="http://schemas.microsoft.com/office/drawing/2014/main" val="645607802"/>
                    </a:ext>
                  </a:extLst>
                </a:gridCol>
                <a:gridCol w="4556271">
                  <a:extLst>
                    <a:ext uri="{9D8B030D-6E8A-4147-A177-3AD203B41FA5}">
                      <a16:colId xmlns:a16="http://schemas.microsoft.com/office/drawing/2014/main" val="2776139959"/>
                    </a:ext>
                  </a:extLst>
                </a:gridCol>
              </a:tblGrid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ction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124325967"/>
                  </a:ext>
                </a:extLst>
              </a:tr>
              <a:tr h="59590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5UTR Py-rich stretch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conferring high transcription level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828412153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90630097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B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the abscisic acid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648625649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essential for the anaerobic indu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526817203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 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conserved DNA modul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428440106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 I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light 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196873935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CGTCC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ABA and VP1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748714814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E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ABA and VP1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235816246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 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684325649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ARE-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ibberellin-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4060977062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CN4_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regulatory element involved in endosperm express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65921186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HS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heat stress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969117891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I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light 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480635681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Skn-1_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required for endosperm express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879951094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-rich repeat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defense and stress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794693117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1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A-elemen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salicylic acid responsivenes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418594169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7518A38-1FD4-9B47-863A-D737FAB18CCF}"/>
              </a:ext>
            </a:extLst>
          </p:cNvPr>
          <p:cNvSpPr txBox="1"/>
          <p:nvPr/>
        </p:nvSpPr>
        <p:spPr>
          <a:xfrm>
            <a:off x="816342" y="248444"/>
            <a:ext cx="46315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1. </a:t>
            </a:r>
            <a:r>
              <a:rPr lang="en-US" sz="1200" b="1" dirty="0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romoter elements identified in </a:t>
            </a:r>
            <a:r>
              <a:rPr lang="en-US" sz="1200" b="1" i="1" dirty="0" err="1"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CitSEPp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0322237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C400DF1-55C8-474C-AE84-F9E01C2AD9EC}"/>
              </a:ext>
            </a:extLst>
          </p:cNvPr>
          <p:cNvGraphicFramePr>
            <a:graphicFrameLocks noGrp="1"/>
          </p:cNvGraphicFramePr>
          <p:nvPr/>
        </p:nvGraphicFramePr>
        <p:xfrm>
          <a:off x="312737" y="705644"/>
          <a:ext cx="5638800" cy="51663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2529">
                  <a:extLst>
                    <a:ext uri="{9D8B030D-6E8A-4147-A177-3AD203B41FA5}">
                      <a16:colId xmlns:a16="http://schemas.microsoft.com/office/drawing/2014/main" val="2095272432"/>
                    </a:ext>
                  </a:extLst>
                </a:gridCol>
                <a:gridCol w="4556271">
                  <a:extLst>
                    <a:ext uri="{9D8B030D-6E8A-4147-A177-3AD203B41FA5}">
                      <a16:colId xmlns:a16="http://schemas.microsoft.com/office/drawing/2014/main" val="969573327"/>
                    </a:ext>
                  </a:extLst>
                </a:gridCol>
              </a:tblGrid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lemen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1045147059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B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the abscisic acid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394813295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C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857510669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TCT-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conserved DNA modul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94686393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1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43524677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HS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heat stress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855685206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B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YB binding site involved in drought-inducibil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711276906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O2-sit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zein metabolism regula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432351175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A-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salicylic acid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06647285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GA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uxin-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185524834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 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conserved DNA modul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279903384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 I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light 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782924246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-W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gal elicitor 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775034399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T1-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light responsive modul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975029557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-rich repeat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defense and stress responsivenes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49826978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7A801BF-F591-8341-8E8F-58EDACDDEBD8}"/>
              </a:ext>
            </a:extLst>
          </p:cNvPr>
          <p:cNvSpPr txBox="1"/>
          <p:nvPr/>
        </p:nvSpPr>
        <p:spPr>
          <a:xfrm>
            <a:off x="792361" y="248444"/>
            <a:ext cx="4679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2. </a:t>
            </a:r>
            <a:r>
              <a:rPr lang="en-US" sz="1200" b="1" dirty="0">
                <a:latin typeface="Times" pitchFamily="2" charset="0"/>
              </a:rPr>
              <a:t>Promoter elements identified in </a:t>
            </a:r>
            <a:r>
              <a:rPr lang="en-US" sz="1200" b="1" i="1" dirty="0" err="1">
                <a:latin typeface="Times" pitchFamily="2" charset="0"/>
              </a:rPr>
              <a:t>CitWAXp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1321153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4E56326-01E3-B947-BA90-6BD57091E469}"/>
              </a:ext>
            </a:extLst>
          </p:cNvPr>
          <p:cNvGraphicFramePr>
            <a:graphicFrameLocks noGrp="1"/>
          </p:cNvGraphicFramePr>
          <p:nvPr/>
        </p:nvGraphicFramePr>
        <p:xfrm>
          <a:off x="312737" y="858044"/>
          <a:ext cx="5638800" cy="61722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71641">
                  <a:extLst>
                    <a:ext uri="{9D8B030D-6E8A-4147-A177-3AD203B41FA5}">
                      <a16:colId xmlns:a16="http://schemas.microsoft.com/office/drawing/2014/main" val="3081743614"/>
                    </a:ext>
                  </a:extLst>
                </a:gridCol>
                <a:gridCol w="4567159">
                  <a:extLst>
                    <a:ext uri="{9D8B030D-6E8A-4147-A177-3AD203B41FA5}">
                      <a16:colId xmlns:a16="http://schemas.microsoft.com/office/drawing/2014/main" val="532083085"/>
                    </a:ext>
                  </a:extLst>
                </a:gridCol>
              </a:tblGrid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774389396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module for light respons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3321981703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essential for the anaerobic indu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1089339427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TCT-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conserved DNA modul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940306856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356789731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HS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heat stress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079228988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B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YB binding site involved in drought-inducibility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078873930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O2-sit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zein metabolism regula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107273218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A-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salicylic acid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850817057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 rich repeat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defense and stress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486693257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1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GA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uxin-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1731826852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 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conserved DNA modul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368203724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 I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light 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00713122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-W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gal elicitor 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4048537995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LTR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low- temperature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833496414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ibberellin-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283126480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-rich repeat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defense and stress responsivenes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361741786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F536E95-83A4-7149-92FA-89AA25D8ACC3}"/>
              </a:ext>
            </a:extLst>
          </p:cNvPr>
          <p:cNvSpPr txBox="1"/>
          <p:nvPr/>
        </p:nvSpPr>
        <p:spPr>
          <a:xfrm>
            <a:off x="795503" y="400844"/>
            <a:ext cx="4673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3. </a:t>
            </a:r>
            <a:r>
              <a:rPr lang="en-US" sz="1200" b="1" dirty="0">
                <a:latin typeface="Times" pitchFamily="2" charset="0"/>
              </a:rPr>
              <a:t>Promoter elements identified in </a:t>
            </a:r>
            <a:r>
              <a:rPr lang="en-US" sz="1200" b="1" i="1" dirty="0" err="1">
                <a:latin typeface="Times" pitchFamily="2" charset="0"/>
              </a:rPr>
              <a:t>CitUNKp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417463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24F225F-37B1-474E-9AEE-EC9ADAC1EB08}"/>
              </a:ext>
            </a:extLst>
          </p:cNvPr>
          <p:cNvGraphicFramePr>
            <a:graphicFrameLocks noGrp="1"/>
          </p:cNvGraphicFramePr>
          <p:nvPr/>
        </p:nvGraphicFramePr>
        <p:xfrm>
          <a:off x="273432" y="705644"/>
          <a:ext cx="5638800" cy="32004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25372">
                  <a:extLst>
                    <a:ext uri="{9D8B030D-6E8A-4147-A177-3AD203B41FA5}">
                      <a16:colId xmlns:a16="http://schemas.microsoft.com/office/drawing/2014/main" val="806941077"/>
                    </a:ext>
                  </a:extLst>
                </a:gridCol>
                <a:gridCol w="4513428">
                  <a:extLst>
                    <a:ext uri="{9D8B030D-6E8A-4147-A177-3AD203B41FA5}">
                      <a16:colId xmlns:a16="http://schemas.microsoft.com/office/drawing/2014/main" val="800597391"/>
                    </a:ext>
                  </a:extLst>
                </a:gridCol>
              </a:tblGrid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1928703327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B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the abscisic acid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85953979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essential for the anaerobic indu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297736446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TCT-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conserved DNA modul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1246096108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1001535561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HS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heat stress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1439850468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B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YB binding site involved in drought-inducibility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3459404175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O2-sit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zein metabolism regula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323672703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CA-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salicylic acid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1939928628"/>
                  </a:ext>
                </a:extLst>
              </a:tr>
              <a:tr h="27468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TGA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uxin-responsive elemen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478" marR="64478" marT="0" marB="0" anchor="ctr"/>
                </a:tc>
                <a:extLst>
                  <a:ext uri="{0D108BD9-81ED-4DB2-BD59-A6C34878D82A}">
                    <a16:rowId xmlns:a16="http://schemas.microsoft.com/office/drawing/2014/main" val="83809085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A0245EA-DE3C-DC42-BE5E-66EF13B017C0}"/>
              </a:ext>
            </a:extLst>
          </p:cNvPr>
          <p:cNvSpPr txBox="1"/>
          <p:nvPr/>
        </p:nvSpPr>
        <p:spPr>
          <a:xfrm>
            <a:off x="761039" y="324644"/>
            <a:ext cx="47421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4. </a:t>
            </a:r>
            <a:r>
              <a:rPr lang="en-US" sz="1200" b="1" dirty="0">
                <a:latin typeface="Times" pitchFamily="2" charset="0"/>
              </a:rPr>
              <a:t>Promoter elements identified in </a:t>
            </a:r>
            <a:r>
              <a:rPr lang="en-US" sz="1200" b="1" i="1" dirty="0" err="1">
                <a:latin typeface="Times" pitchFamily="2" charset="0"/>
              </a:rPr>
              <a:t>CitJuSacp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6043051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E22409A-5BC8-B24B-8285-95CB71903FB8}"/>
              </a:ext>
            </a:extLst>
          </p:cNvPr>
          <p:cNvGraphicFramePr>
            <a:graphicFrameLocks noGrp="1"/>
          </p:cNvGraphicFramePr>
          <p:nvPr/>
        </p:nvGraphicFramePr>
        <p:xfrm>
          <a:off x="215679" y="781844"/>
          <a:ext cx="5638800" cy="35661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36806">
                  <a:extLst>
                    <a:ext uri="{9D8B030D-6E8A-4147-A177-3AD203B41FA5}">
                      <a16:colId xmlns:a16="http://schemas.microsoft.com/office/drawing/2014/main" val="2088012623"/>
                    </a:ext>
                  </a:extLst>
                </a:gridCol>
                <a:gridCol w="4501994">
                  <a:extLst>
                    <a:ext uri="{9D8B030D-6E8A-4147-A177-3AD203B41FA5}">
                      <a16:colId xmlns:a16="http://schemas.microsoft.com/office/drawing/2014/main" val="1716082333"/>
                    </a:ext>
                  </a:extLst>
                </a:gridCol>
              </a:tblGrid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lemen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1769470719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AGAA-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 acting regulatory element involved in seed specific express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3011757616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essential for the anaerobic indu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2108218345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B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the abscisic acid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1457138233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1897061283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HS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heat stress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197754965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B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YB binding site involved in drought-inducibility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290067870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O2-sit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zein metabolism regula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424738071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T-rich sequenc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lement for maximal elicitor-mediated activation (2copies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44283795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O2-sit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</a:t>
                      </a:r>
                      <a:r>
                        <a:rPr lang="en-US" sz="1200" kern="1200" dirty="0" err="1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zein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 metabolism regulation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/>
                </a:tc>
                <a:extLst>
                  <a:ext uri="{0D108BD9-81ED-4DB2-BD59-A6C34878D82A}">
                    <a16:rowId xmlns:a16="http://schemas.microsoft.com/office/drawing/2014/main" val="342259439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519BEFC-1D5D-ED45-BC7C-0F4218E0AED9}"/>
              </a:ext>
            </a:extLst>
          </p:cNvPr>
          <p:cNvSpPr txBox="1"/>
          <p:nvPr/>
        </p:nvSpPr>
        <p:spPr>
          <a:xfrm>
            <a:off x="781878" y="324644"/>
            <a:ext cx="4700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5. </a:t>
            </a:r>
            <a:r>
              <a:rPr lang="en-US" sz="1200" b="1" dirty="0">
                <a:latin typeface="Times" pitchFamily="2" charset="0"/>
              </a:rPr>
              <a:t>Promoter element identified in </a:t>
            </a:r>
            <a:r>
              <a:rPr lang="en-US" sz="1200" b="1" i="1" dirty="0">
                <a:latin typeface="Times" pitchFamily="2" charset="0"/>
              </a:rPr>
              <a:t>CitVO1/2p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9073599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8A4FC1F-8673-3143-A4B2-C5B7EE930629}"/>
              </a:ext>
            </a:extLst>
          </p:cNvPr>
          <p:cNvGraphicFramePr>
            <a:graphicFrameLocks noGrp="1"/>
          </p:cNvGraphicFramePr>
          <p:nvPr/>
        </p:nvGraphicFramePr>
        <p:xfrm>
          <a:off x="312737" y="781844"/>
          <a:ext cx="5638799" cy="416052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73974">
                  <a:extLst>
                    <a:ext uri="{9D8B030D-6E8A-4147-A177-3AD203B41FA5}">
                      <a16:colId xmlns:a16="http://schemas.microsoft.com/office/drawing/2014/main" val="1725770290"/>
                    </a:ext>
                  </a:extLst>
                </a:gridCol>
                <a:gridCol w="4664825">
                  <a:extLst>
                    <a:ext uri="{9D8B030D-6E8A-4147-A177-3AD203B41FA5}">
                      <a16:colId xmlns:a16="http://schemas.microsoft.com/office/drawing/2014/main" val="1606505675"/>
                    </a:ext>
                  </a:extLst>
                </a:gridCol>
              </a:tblGrid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Elemen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841997139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TCT-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conserved DNA modul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986608558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essential for the anaerobic induc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602095986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B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the abscisic acid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468997987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G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regulatory element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83816786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HS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is-acting element involved in heat stress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96915737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B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YB binding site involved in drought-inducibility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279131725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-W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fungal elicitor responsiv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1113628962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Box 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conserved DNA modul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875507333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CAG-moti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part of a light response eleme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314300032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BSI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YB binding site involved in flavonoid biosynthetic genes regula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255163331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MYB binding site involved in light responsivenes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540845624"/>
                  </a:ext>
                </a:extLst>
              </a:tr>
              <a:tr h="27747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as-2-box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pc="-5" dirty="0">
                          <a:solidFill>
                            <a:schemeClr val="tx1"/>
                          </a:solidFill>
                          <a:effectLst/>
                          <a:latin typeface="Times" pitchFamily="2" charset="0"/>
                        </a:rPr>
                        <a:t>involved in shoot-specific expression and light responsivenes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" pitchFamily="2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133" marR="65133" marT="0" marB="0" anchor="ctr"/>
                </a:tc>
                <a:extLst>
                  <a:ext uri="{0D108BD9-81ED-4DB2-BD59-A6C34878D82A}">
                    <a16:rowId xmlns:a16="http://schemas.microsoft.com/office/drawing/2014/main" val="3588956558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030E44E-2340-6146-8474-AD7A752F0550}"/>
              </a:ext>
            </a:extLst>
          </p:cNvPr>
          <p:cNvSpPr txBox="1"/>
          <p:nvPr/>
        </p:nvSpPr>
        <p:spPr>
          <a:xfrm>
            <a:off x="713749" y="324644"/>
            <a:ext cx="4836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S6. </a:t>
            </a:r>
            <a:r>
              <a:rPr lang="en-US" sz="1200" b="1" dirty="0">
                <a:latin typeface="Times" pitchFamily="2" charset="0"/>
              </a:rPr>
              <a:t>Promoter elements identified in </a:t>
            </a:r>
            <a:r>
              <a:rPr lang="en-US" sz="1200" b="1" i="1" dirty="0" err="1">
                <a:latin typeface="Times" pitchFamily="2" charset="0"/>
              </a:rPr>
              <a:t>PamMybAp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977624015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613</TotalTime>
  <Words>819</Words>
  <Application>Microsoft Macintosh PowerPoint</Application>
  <PresentationFormat>Custom</PresentationFormat>
  <Paragraphs>19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Times</vt:lpstr>
      <vt:lpstr>Times New Roman</vt:lpstr>
      <vt:lpstr>Default 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SDA, ARS, WRRC, Albany C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thilmony</dc:creator>
  <cp:lastModifiedBy>Thomson, James - ARS</cp:lastModifiedBy>
  <cp:revision>1258</cp:revision>
  <dcterms:created xsi:type="dcterms:W3CDTF">2013-03-19T23:20:18Z</dcterms:created>
  <dcterms:modified xsi:type="dcterms:W3CDTF">2020-07-06T22:17:31Z</dcterms:modified>
</cp:coreProperties>
</file>